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27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174D48-B6B3-4E90-905B-34FB3918AB7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60D6BD-AC9A-4B51-8EC5-4EE1ACC2E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48093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206153-1A6D-46AD-9E56-C8F0EBB7277B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CD1143-941C-463C-892A-006404F24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456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497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01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362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613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301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24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828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625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440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03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60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890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>
            <a:grpSpLocks noChangeAspect="1"/>
          </p:cNvGrpSpPr>
          <p:nvPr/>
        </p:nvGrpSpPr>
        <p:grpSpPr>
          <a:xfrm>
            <a:off x="4439310" y="656499"/>
            <a:ext cx="6342260" cy="4572000"/>
            <a:chOff x="7185355" y="824725"/>
            <a:chExt cx="3525794" cy="2684594"/>
          </a:xfrm>
        </p:grpSpPr>
        <p:graphicFrame>
          <p:nvGraphicFramePr>
            <p:cNvPr id="18" name="Object 17"/>
            <p:cNvGraphicFramePr>
              <a:graphicFrameLocks noChangeAspect="1"/>
            </p:cNvGraphicFramePr>
            <p:nvPr>
              <p:extLst/>
            </p:nvPr>
          </p:nvGraphicFramePr>
          <p:xfrm>
            <a:off x="7185355" y="824725"/>
            <a:ext cx="3525794" cy="26845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444" name="Graph" r:id="rId3" imgW="3920760" imgH="3000960" progId="Origin50.Graph">
                    <p:embed/>
                  </p:oleObj>
                </mc:Choice>
                <mc:Fallback>
                  <p:oleObj name="Graph" r:id="rId3" imgW="3920760" imgH="300096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185355" y="824725"/>
                          <a:ext cx="3525794" cy="268459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Object 18"/>
            <p:cNvGraphicFramePr>
              <a:graphicFrameLocks noChangeAspect="1"/>
            </p:cNvGraphicFramePr>
            <p:nvPr>
              <p:extLst/>
            </p:nvPr>
          </p:nvGraphicFramePr>
          <p:xfrm>
            <a:off x="7281576" y="824725"/>
            <a:ext cx="3273984" cy="26845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445" name="Graph" r:id="rId5" imgW="3920760" imgH="3000960" progId="Origin50.Graph">
                    <p:embed/>
                  </p:oleObj>
                </mc:Choice>
                <mc:Fallback>
                  <p:oleObj name="Graph" r:id="rId5" imgW="3920760" imgH="300096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281576" y="824725"/>
                          <a:ext cx="3273984" cy="268459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0" name="TextBox 19"/>
          <p:cNvSpPr txBox="1"/>
          <p:nvPr/>
        </p:nvSpPr>
        <p:spPr>
          <a:xfrm>
            <a:off x="6015343" y="4457142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yst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516526" y="4458912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3676047" y="2690446"/>
            <a:ext cx="2245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anx1 intensity,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.u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grpSp>
        <p:nvGrpSpPr>
          <p:cNvPr id="26" name="Group 25"/>
          <p:cNvGrpSpPr>
            <a:grpSpLocks noChangeAspect="1"/>
          </p:cNvGrpSpPr>
          <p:nvPr/>
        </p:nvGrpSpPr>
        <p:grpSpPr>
          <a:xfrm>
            <a:off x="325691" y="589111"/>
            <a:ext cx="4291370" cy="4466273"/>
            <a:chOff x="4295560" y="1444476"/>
            <a:chExt cx="1381458" cy="1437762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295560" y="1444476"/>
              <a:ext cx="1381458" cy="1437762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4581327" y="2533186"/>
              <a:ext cx="236657" cy="1188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yst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7584747">
              <a:off x="5477129" y="2003890"/>
              <a:ext cx="166781" cy="1188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D</a:t>
              </a: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5163414" y="2849315"/>
              <a:ext cx="463138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5228297" y="2720358"/>
              <a:ext cx="308690" cy="1188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300 µm</a:t>
              </a: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151888" y="5718040"/>
            <a:ext cx="12047509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 - IHC staining with polyclonal antibodies in human ADPKD biopsy shows higher PANX1 level in cystic epithelium than collecting ducts (CD). The effect was observed in both non-truncating and truncating mutations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n the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Pkd1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structure (blue and red dots, respectively); B – C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ontrol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periment for Figure 1 stained with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ouse IgG2aκ isotype antibodies in a healthy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dividual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kidney. CD – collecting duct, G- glomeruli, PT – proximal tubules. *p&lt;0.05 vs CD per paired t-test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04089" y="13337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824274" y="42442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091609" y="1513912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292403" y="354238"/>
            <a:ext cx="958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893920" y="2960848"/>
            <a:ext cx="4991991" cy="27432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893920" y="148681"/>
            <a:ext cx="3705500" cy="2743200"/>
          </a:xfrm>
          <a:prstGeom prst="rect">
            <a:avLst/>
          </a:prstGeom>
          <a:ln w="22225">
            <a:solidFill>
              <a:schemeClr val="dk1"/>
            </a:solidFill>
          </a:ln>
        </p:spPr>
      </p:pic>
      <p:cxnSp>
        <p:nvCxnSpPr>
          <p:cNvPr id="4" name="Straight Connector 3"/>
          <p:cNvCxnSpPr/>
          <p:nvPr/>
        </p:nvCxnSpPr>
        <p:spPr>
          <a:xfrm rot="5400000" flipH="1" flipV="1">
            <a:off x="11453344" y="5337844"/>
            <a:ext cx="0" cy="374904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7162828" y="2617948"/>
            <a:ext cx="778471" cy="0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6893920" y="2960848"/>
            <a:ext cx="1952900" cy="1253012"/>
          </a:xfrm>
          <a:prstGeom prst="rect">
            <a:avLst/>
          </a:prstGeom>
          <a:noFill/>
          <a:ln w="222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Bent-Up Arrow 36"/>
          <p:cNvSpPr/>
          <p:nvPr/>
        </p:nvSpPr>
        <p:spPr>
          <a:xfrm>
            <a:off x="8846820" y="2907191"/>
            <a:ext cx="728980" cy="534509"/>
          </a:xfrm>
          <a:prstGeom prst="bentUpArrow">
            <a:avLst/>
          </a:prstGeom>
          <a:noFill/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10973885" y="5155963"/>
            <a:ext cx="958917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7017361" y="2287747"/>
            <a:ext cx="958917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6583798" y="1333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7584747">
            <a:off x="9277360" y="829333"/>
            <a:ext cx="389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168016" y="802841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0181442" y="1335615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8350117" y="2567335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0135732" y="253572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6396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81</TotalTime>
  <Words>115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Graph</vt:lpstr>
      <vt:lpstr>PowerPoint Presentation</vt:lpstr>
    </vt:vector>
  </TitlesOfParts>
  <Company>HF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lov, Tengis</dc:creator>
  <cp:lastModifiedBy>Pavlov, Tengis</cp:lastModifiedBy>
  <cp:revision>235</cp:revision>
  <cp:lastPrinted>2022-11-30T15:40:23Z</cp:lastPrinted>
  <dcterms:created xsi:type="dcterms:W3CDTF">2021-03-26T14:03:45Z</dcterms:created>
  <dcterms:modified xsi:type="dcterms:W3CDTF">2023-03-13T14:37:11Z</dcterms:modified>
</cp:coreProperties>
</file>